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19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9E4F5-9A47-4201-9D6A-5DBF0F73CC93}" type="datetimeFigureOut">
              <a:rPr lang="zh-CN" altLang="en-US" smtClean="0"/>
              <a:t>2025-01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603C-D981-4BD0-B18D-729807D89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45340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9E4F5-9A47-4201-9D6A-5DBF0F73CC93}" type="datetimeFigureOut">
              <a:rPr lang="zh-CN" altLang="en-US" smtClean="0"/>
              <a:t>2025-01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603C-D981-4BD0-B18D-729807D89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34052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9E4F5-9A47-4201-9D6A-5DBF0F73CC93}" type="datetimeFigureOut">
              <a:rPr lang="zh-CN" altLang="en-US" smtClean="0"/>
              <a:t>2025-01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603C-D981-4BD0-B18D-729807D89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7491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9E4F5-9A47-4201-9D6A-5DBF0F73CC93}" type="datetimeFigureOut">
              <a:rPr lang="zh-CN" altLang="en-US" smtClean="0"/>
              <a:t>2025-01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603C-D981-4BD0-B18D-729807D89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7996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9E4F5-9A47-4201-9D6A-5DBF0F73CC93}" type="datetimeFigureOut">
              <a:rPr lang="zh-CN" altLang="en-US" smtClean="0"/>
              <a:t>2025-01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603C-D981-4BD0-B18D-729807D89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8728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9E4F5-9A47-4201-9D6A-5DBF0F73CC93}" type="datetimeFigureOut">
              <a:rPr lang="zh-CN" altLang="en-US" smtClean="0"/>
              <a:t>2025-01-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603C-D981-4BD0-B18D-729807D89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6857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9E4F5-9A47-4201-9D6A-5DBF0F73CC93}" type="datetimeFigureOut">
              <a:rPr lang="zh-CN" altLang="en-US" smtClean="0"/>
              <a:t>2025-01-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603C-D981-4BD0-B18D-729807D89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705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9E4F5-9A47-4201-9D6A-5DBF0F73CC93}" type="datetimeFigureOut">
              <a:rPr lang="zh-CN" altLang="en-US" smtClean="0"/>
              <a:t>2025-01-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603C-D981-4BD0-B18D-729807D89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389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9E4F5-9A47-4201-9D6A-5DBF0F73CC93}" type="datetimeFigureOut">
              <a:rPr lang="zh-CN" altLang="en-US" smtClean="0"/>
              <a:t>2025-01-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603C-D981-4BD0-B18D-729807D89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6712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9E4F5-9A47-4201-9D6A-5DBF0F73CC93}" type="datetimeFigureOut">
              <a:rPr lang="zh-CN" altLang="en-US" smtClean="0"/>
              <a:t>2025-01-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603C-D981-4BD0-B18D-729807D89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0351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9E4F5-9A47-4201-9D6A-5DBF0F73CC93}" type="datetimeFigureOut">
              <a:rPr lang="zh-CN" altLang="en-US" smtClean="0"/>
              <a:t>2025-01-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603C-D981-4BD0-B18D-729807D89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2751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59E4F5-9A47-4201-9D6A-5DBF0F73CC93}" type="datetimeFigureOut">
              <a:rPr lang="zh-CN" altLang="en-US" smtClean="0"/>
              <a:t>2025-01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0F603C-D981-4BD0-B18D-729807D89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38266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18s rRNA">
            <a:extLst>
              <a:ext uri="{FF2B5EF4-FFF2-40B4-BE49-F238E27FC236}">
                <a16:creationId xmlns:a16="http://schemas.microsoft.com/office/drawing/2014/main" id="{F74027C7-E168-C51E-B2FC-FA6E70C650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7947" y="2931601"/>
            <a:ext cx="2403000" cy="1367481"/>
          </a:xfrm>
          <a:prstGeom prst="rect">
            <a:avLst/>
          </a:prstGeom>
        </p:spPr>
      </p:pic>
      <p:pic>
        <p:nvPicPr>
          <p:cNvPr id="5" name="图片 4" descr="Ef1-a">
            <a:extLst>
              <a:ext uri="{FF2B5EF4-FFF2-40B4-BE49-F238E27FC236}">
                <a16:creationId xmlns:a16="http://schemas.microsoft.com/office/drawing/2014/main" id="{B240B82E-81BE-49E6-79A3-BC3D35EEAF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7947" y="126958"/>
            <a:ext cx="2403000" cy="1367481"/>
          </a:xfrm>
          <a:prstGeom prst="rect">
            <a:avLst/>
          </a:prstGeom>
        </p:spPr>
      </p:pic>
      <p:pic>
        <p:nvPicPr>
          <p:cNvPr id="6" name="图片 5" descr="RPS18">
            <a:extLst>
              <a:ext uri="{FF2B5EF4-FFF2-40B4-BE49-F238E27FC236}">
                <a16:creationId xmlns:a16="http://schemas.microsoft.com/office/drawing/2014/main" id="{33613FB1-46C4-493A-FB36-4B376CAF0CC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05839" y="126958"/>
            <a:ext cx="2403000" cy="1367481"/>
          </a:xfrm>
          <a:prstGeom prst="rect">
            <a:avLst/>
          </a:prstGeom>
        </p:spPr>
      </p:pic>
      <p:pic>
        <p:nvPicPr>
          <p:cNvPr id="7" name="图片 6" descr="RPL32">
            <a:extLst>
              <a:ext uri="{FF2B5EF4-FFF2-40B4-BE49-F238E27FC236}">
                <a16:creationId xmlns:a16="http://schemas.microsoft.com/office/drawing/2014/main" id="{6520AB63-E98F-F9C0-6C4D-3D060C1C4B2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27947" y="1529279"/>
            <a:ext cx="2403000" cy="1367481"/>
          </a:xfrm>
          <a:prstGeom prst="rect">
            <a:avLst/>
          </a:prstGeom>
        </p:spPr>
      </p:pic>
      <p:pic>
        <p:nvPicPr>
          <p:cNvPr id="8" name="图片 7" descr="GAPDH">
            <a:extLst>
              <a:ext uri="{FF2B5EF4-FFF2-40B4-BE49-F238E27FC236}">
                <a16:creationId xmlns:a16="http://schemas.microsoft.com/office/drawing/2014/main" id="{35A5398F-2C20-735B-CFA6-04F1748C137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05839" y="1528807"/>
            <a:ext cx="2403000" cy="1367481"/>
          </a:xfrm>
          <a:prstGeom prst="rect">
            <a:avLst/>
          </a:prstGeom>
        </p:spPr>
      </p:pic>
      <p:pic>
        <p:nvPicPr>
          <p:cNvPr id="9" name="图片 8" descr="TUB">
            <a:extLst>
              <a:ext uri="{FF2B5EF4-FFF2-40B4-BE49-F238E27FC236}">
                <a16:creationId xmlns:a16="http://schemas.microsoft.com/office/drawing/2014/main" id="{96DBCFB0-2DEC-2776-5813-6F6CAC73ED27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605839" y="2930656"/>
            <a:ext cx="2403000" cy="1368900"/>
          </a:xfrm>
          <a:prstGeom prst="rect">
            <a:avLst/>
          </a:prstGeom>
        </p:spPr>
      </p:pic>
      <p:pic>
        <p:nvPicPr>
          <p:cNvPr id="10" name="图片 9" descr="TPB1">
            <a:extLst>
              <a:ext uri="{FF2B5EF4-FFF2-40B4-BE49-F238E27FC236}">
                <a16:creationId xmlns:a16="http://schemas.microsoft.com/office/drawing/2014/main" id="{374C4B38-984E-BD4B-A750-84EA043B68BD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1127947" y="4333923"/>
            <a:ext cx="2403000" cy="1368900"/>
          </a:xfrm>
          <a:prstGeom prst="rect">
            <a:avLst/>
          </a:prstGeom>
        </p:spPr>
      </p:pic>
      <p:pic>
        <p:nvPicPr>
          <p:cNvPr id="11" name="图片 10" descr="Actin 1">
            <a:extLst>
              <a:ext uri="{FF2B5EF4-FFF2-40B4-BE49-F238E27FC236}">
                <a16:creationId xmlns:a16="http://schemas.microsoft.com/office/drawing/2014/main" id="{3B08964C-E163-CF42-62BA-137D4DF2799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05839" y="4333923"/>
            <a:ext cx="2403000" cy="1367481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474BC5AD-CB00-0D2B-86FA-23ACAC9DD1B2}"/>
              </a:ext>
            </a:extLst>
          </p:cNvPr>
          <p:cNvSpPr txBox="1"/>
          <p:nvPr/>
        </p:nvSpPr>
        <p:spPr>
          <a:xfrm>
            <a:off x="1053055" y="39662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2D9B7EB-4527-B2D4-CAD5-F0A0740D7B59}"/>
              </a:ext>
            </a:extLst>
          </p:cNvPr>
          <p:cNvSpPr txBox="1"/>
          <p:nvPr/>
        </p:nvSpPr>
        <p:spPr>
          <a:xfrm>
            <a:off x="3519930" y="0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8AFD0AD-5C18-9B7A-4DBF-FA3EFA9CC6F2}"/>
              </a:ext>
            </a:extLst>
          </p:cNvPr>
          <p:cNvSpPr txBox="1"/>
          <p:nvPr/>
        </p:nvSpPr>
        <p:spPr>
          <a:xfrm>
            <a:off x="1053055" y="1485159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3176851-B477-CF72-B80E-1005A6C67A7E}"/>
              </a:ext>
            </a:extLst>
          </p:cNvPr>
          <p:cNvSpPr txBox="1"/>
          <p:nvPr/>
        </p:nvSpPr>
        <p:spPr>
          <a:xfrm>
            <a:off x="3519930" y="1445497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FCA7697-3C2B-5B91-B60E-D16CFCB5BA42}"/>
              </a:ext>
            </a:extLst>
          </p:cNvPr>
          <p:cNvSpPr txBox="1"/>
          <p:nvPr/>
        </p:nvSpPr>
        <p:spPr>
          <a:xfrm>
            <a:off x="1053055" y="2808992"/>
            <a:ext cx="26642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878F2021-6BA3-15AF-CCFB-F3CC33F85D9F}"/>
              </a:ext>
            </a:extLst>
          </p:cNvPr>
          <p:cNvSpPr txBox="1"/>
          <p:nvPr/>
        </p:nvSpPr>
        <p:spPr>
          <a:xfrm>
            <a:off x="3519930" y="2769330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73ADC43C-BA05-3B9F-376A-4EC3932126D6}"/>
              </a:ext>
            </a:extLst>
          </p:cNvPr>
          <p:cNvSpPr txBox="1"/>
          <p:nvPr/>
        </p:nvSpPr>
        <p:spPr>
          <a:xfrm>
            <a:off x="1053055" y="4246153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FC9A160-2CB5-EFBA-19C5-BA94EFADE75F}"/>
              </a:ext>
            </a:extLst>
          </p:cNvPr>
          <p:cNvSpPr txBox="1"/>
          <p:nvPr/>
        </p:nvSpPr>
        <p:spPr>
          <a:xfrm>
            <a:off x="3519930" y="4206491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861A4A1-4C8C-8BC5-FDFE-0EC189CDC864}"/>
              </a:ext>
            </a:extLst>
          </p:cNvPr>
          <p:cNvSpPr txBox="1"/>
          <p:nvPr/>
        </p:nvSpPr>
        <p:spPr>
          <a:xfrm>
            <a:off x="6094748" y="1628505"/>
            <a:ext cx="2886364" cy="25355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1. Melting curve of </a:t>
            </a:r>
            <a:r>
              <a:rPr lang="en-US" altLang="zh-CN" sz="18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PCR of candidate reference gene. A:EF1-</a:t>
            </a:r>
            <a:r>
              <a:rPr lang="el-GR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 B:RPS18, C:RPL32, D: GAPDH, E: 18s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DNA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 F: TUB, G: TPB, H:Actin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94218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0</TotalTime>
  <Words>54</Words>
  <Application>Microsoft Office PowerPoint</Application>
  <PresentationFormat>全屏显示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k</dc:creator>
  <cp:lastModifiedBy>kk</cp:lastModifiedBy>
  <cp:revision>3</cp:revision>
  <dcterms:created xsi:type="dcterms:W3CDTF">2025-01-10T02:59:30Z</dcterms:created>
  <dcterms:modified xsi:type="dcterms:W3CDTF">2025-01-10T03:10:16Z</dcterms:modified>
</cp:coreProperties>
</file>